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C1D302-2CF0-4DDE-AEE9-D64D44C7E7C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B461AF-29B8-49EF-A2F0-AA16E72656C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14E857-86AD-4BC3-8005-7540A194225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6AB34E-8532-415C-9DBD-497D79522D0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010E6E-AC16-4745-80EA-588936A096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9670A1-75D5-40AA-98ED-BBDDEF88DC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6BDFC8-94BC-4CBA-8AC5-7387C1E080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C92037-B7BE-496A-ACE1-7E8927F70A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6C11A2-DA97-4622-ABFE-DE8E318A6F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81CFCD-F1DD-40C6-8F0D-746E689D4F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FBAA77-E4B7-42F6-A691-65836B2310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04A371-B3DA-4D12-9D45-37987B7573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1280" indent="-3412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1240" indent="-2840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1560" indent="-22716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598760" indent="-2271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87D7F10-41B0-40C4-8506-337BA18C4FE9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ZoneTexte 32"/>
          <p:cNvSpPr/>
          <p:nvPr/>
        </p:nvSpPr>
        <p:spPr>
          <a:xfrm>
            <a:off x="179280" y="100080"/>
            <a:ext cx="260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Times New Roman"/>
              </a:rPr>
              <a:t>Supplementary Figure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e 1"/>
          <p:cNvGrpSpPr/>
          <p:nvPr/>
        </p:nvGrpSpPr>
        <p:grpSpPr>
          <a:xfrm>
            <a:off x="3755880" y="668160"/>
            <a:ext cx="4848480" cy="1576800"/>
            <a:chOff x="3755880" y="668160"/>
            <a:chExt cx="4848480" cy="1576800"/>
          </a:xfrm>
        </p:grpSpPr>
        <p:grpSp>
          <p:nvGrpSpPr>
            <p:cNvPr id="43" name="Groupe 3"/>
            <p:cNvGrpSpPr/>
            <p:nvPr/>
          </p:nvGrpSpPr>
          <p:grpSpPr>
            <a:xfrm>
              <a:off x="3755880" y="985320"/>
              <a:ext cx="4351680" cy="1233720"/>
              <a:chOff x="3755880" y="985320"/>
              <a:chExt cx="4351680" cy="1233720"/>
            </a:xfrm>
          </p:grpSpPr>
          <p:sp>
            <p:nvSpPr>
              <p:cNvPr id="44" name="ZoneTexte 4"/>
              <p:cNvSpPr/>
              <p:nvPr/>
            </p:nvSpPr>
            <p:spPr>
              <a:xfrm>
                <a:off x="5224320" y="1760040"/>
                <a:ext cx="100152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</a:rPr>
                  <a:t>NPD 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" name="Connecteur droit 5"/>
              <p:cNvSpPr/>
              <p:nvPr/>
            </p:nvSpPr>
            <p:spPr>
              <a:xfrm>
                <a:off x="4255920" y="1577880"/>
                <a:ext cx="3851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" name="Connecteur droit 6"/>
              <p:cNvSpPr/>
              <p:nvPr/>
            </p:nvSpPr>
            <p:spPr>
              <a:xfrm>
                <a:off x="4255920" y="1344600"/>
                <a:ext cx="0" cy="233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" name="Connecteur droit 7"/>
              <p:cNvSpPr/>
              <p:nvPr/>
            </p:nvSpPr>
            <p:spPr>
              <a:xfrm>
                <a:off x="5342040" y="1344600"/>
                <a:ext cx="0" cy="233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" name="Connecteur droit 8"/>
              <p:cNvSpPr/>
              <p:nvPr/>
            </p:nvSpPr>
            <p:spPr>
              <a:xfrm>
                <a:off x="5543640" y="1341360"/>
                <a:ext cx="0" cy="233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Connecteur droit 9"/>
              <p:cNvSpPr/>
              <p:nvPr/>
            </p:nvSpPr>
            <p:spPr>
              <a:xfrm>
                <a:off x="5748480" y="1350720"/>
                <a:ext cx="0" cy="233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ZoneTexte 10"/>
              <p:cNvSpPr/>
              <p:nvPr/>
            </p:nvSpPr>
            <p:spPr>
              <a:xfrm>
                <a:off x="3755880" y="1757520"/>
                <a:ext cx="100008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</a:rPr>
                  <a:t>NPD 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ZoneTexte 11"/>
              <p:cNvSpPr/>
              <p:nvPr/>
            </p:nvSpPr>
            <p:spPr>
              <a:xfrm>
                <a:off x="4273200" y="1369800"/>
                <a:ext cx="1182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 week (recovery)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ZoneTexte 12"/>
              <p:cNvSpPr/>
              <p:nvPr/>
            </p:nvSpPr>
            <p:spPr>
              <a:xfrm>
                <a:off x="5295600" y="1369800"/>
                <a:ext cx="366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</a:rPr>
                  <a:t>D1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ZoneTexte 13"/>
              <p:cNvSpPr/>
              <p:nvPr/>
            </p:nvSpPr>
            <p:spPr>
              <a:xfrm>
                <a:off x="5489640" y="1371240"/>
                <a:ext cx="366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</a:rPr>
                  <a:t>D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54" name="Connecteur droit avec flèche 18"/>
              <p:cNvCxnSpPr/>
              <p:nvPr/>
            </p:nvCxnSpPr>
            <p:spPr>
              <a:xfrm flipV="1">
                <a:off x="4255560" y="1604520"/>
                <a:ext cx="1080" cy="10872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  <p:cxnSp>
            <p:nvCxnSpPr>
              <p:cNvPr id="55" name="Connecteur droit avec flèche 19"/>
              <p:cNvCxnSpPr/>
              <p:nvPr/>
            </p:nvCxnSpPr>
            <p:spPr>
              <a:xfrm flipV="1">
                <a:off x="5749560" y="1625040"/>
                <a:ext cx="1080" cy="10872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  <p:cxnSp>
            <p:nvCxnSpPr>
              <p:cNvPr id="56" name="Connecteur droit avec flèche 23"/>
              <p:cNvCxnSpPr/>
              <p:nvPr/>
            </p:nvCxnSpPr>
            <p:spPr>
              <a:xfrm>
                <a:off x="5341680" y="985320"/>
                <a:ext cx="1080" cy="20052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  <p:cxnSp>
          <p:nvCxnSpPr>
            <p:cNvPr id="57" name="Connecteur droit avec flèche 66"/>
            <p:cNvCxnSpPr/>
            <p:nvPr/>
          </p:nvCxnSpPr>
          <p:spPr>
            <a:xfrm>
              <a:off x="5536800" y="994680"/>
              <a:ext cx="1080" cy="1990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58" name="ZoneTexte 67"/>
            <p:cNvSpPr/>
            <p:nvPr/>
          </p:nvSpPr>
          <p:spPr>
            <a:xfrm>
              <a:off x="4912920" y="668160"/>
              <a:ext cx="1000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NaCl 0,9%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Connecteur droit 69"/>
            <p:cNvSpPr/>
            <p:nvPr/>
          </p:nvSpPr>
          <p:spPr>
            <a:xfrm>
              <a:off x="6707160" y="1355760"/>
              <a:ext cx="0" cy="231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Connecteur droit 70"/>
            <p:cNvSpPr/>
            <p:nvPr/>
          </p:nvSpPr>
          <p:spPr>
            <a:xfrm>
              <a:off x="6899400" y="1355760"/>
              <a:ext cx="0" cy="231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Connecteur droit 71"/>
            <p:cNvSpPr/>
            <p:nvPr/>
          </p:nvSpPr>
          <p:spPr>
            <a:xfrm>
              <a:off x="7102440" y="1355760"/>
              <a:ext cx="0" cy="231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Connecteur droit 73"/>
            <p:cNvSpPr/>
            <p:nvPr/>
          </p:nvSpPr>
          <p:spPr>
            <a:xfrm>
              <a:off x="8106120" y="1355760"/>
              <a:ext cx="0" cy="231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ZoneTexte 75"/>
            <p:cNvSpPr/>
            <p:nvPr/>
          </p:nvSpPr>
          <p:spPr>
            <a:xfrm>
              <a:off x="6657840" y="1371240"/>
              <a:ext cx="36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Times New Roman"/>
                </a:rPr>
                <a:t>D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ZoneTexte 76"/>
            <p:cNvSpPr/>
            <p:nvPr/>
          </p:nvSpPr>
          <p:spPr>
            <a:xfrm>
              <a:off x="6834240" y="1371240"/>
              <a:ext cx="36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Times New Roman"/>
                </a:rPr>
                <a:t>D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ZoneTexte 77"/>
            <p:cNvSpPr/>
            <p:nvPr/>
          </p:nvSpPr>
          <p:spPr>
            <a:xfrm>
              <a:off x="5680080" y="1371600"/>
              <a:ext cx="1116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 week (recovery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ZoneTexte 78"/>
            <p:cNvSpPr/>
            <p:nvPr/>
          </p:nvSpPr>
          <p:spPr>
            <a:xfrm>
              <a:off x="7053480" y="1371600"/>
              <a:ext cx="134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 week (recovery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67" name="Connecteur droit avec flèche 80"/>
            <p:cNvCxnSpPr/>
            <p:nvPr/>
          </p:nvCxnSpPr>
          <p:spPr>
            <a:xfrm flipV="1">
              <a:off x="7095960" y="1625040"/>
              <a:ext cx="1080" cy="1083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68" name="ZoneTexte 81"/>
            <p:cNvSpPr/>
            <p:nvPr/>
          </p:nvSpPr>
          <p:spPr>
            <a:xfrm>
              <a:off x="6597720" y="1785960"/>
              <a:ext cx="10000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</a:rPr>
                <a:t>NPD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ZoneTexte 82"/>
            <p:cNvSpPr/>
            <p:nvPr/>
          </p:nvSpPr>
          <p:spPr>
            <a:xfrm>
              <a:off x="6305400" y="680760"/>
              <a:ext cx="10000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</a:rPr>
                <a:t>c407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70" name="Connecteur droit avec flèche 83"/>
            <p:cNvCxnSpPr/>
            <p:nvPr/>
          </p:nvCxnSpPr>
          <p:spPr>
            <a:xfrm>
              <a:off x="6706800" y="1021680"/>
              <a:ext cx="1080" cy="20052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71" name="Connecteur droit avec flèche 84"/>
            <p:cNvCxnSpPr/>
            <p:nvPr/>
          </p:nvCxnSpPr>
          <p:spPr>
            <a:xfrm>
              <a:off x="6899040" y="1021680"/>
              <a:ext cx="1080" cy="20052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72" name="Connecteur droit avec flèche 81"/>
            <p:cNvCxnSpPr/>
            <p:nvPr/>
          </p:nvCxnSpPr>
          <p:spPr>
            <a:xfrm flipV="1">
              <a:off x="8102520" y="1608840"/>
              <a:ext cx="1080" cy="1083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73" name="ZoneTexte 81"/>
            <p:cNvSpPr/>
            <p:nvPr/>
          </p:nvSpPr>
          <p:spPr>
            <a:xfrm>
              <a:off x="7604280" y="1769760"/>
              <a:ext cx="10000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</a:rPr>
                <a:t>NPD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4" name="ZoneTexte 55"/>
          <p:cNvSpPr/>
          <p:nvPr/>
        </p:nvSpPr>
        <p:spPr>
          <a:xfrm>
            <a:off x="179280" y="1317600"/>
            <a:ext cx="2853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2000" spc="-1" strike="noStrike">
                <a:solidFill>
                  <a:srgbClr val="000000"/>
                </a:solidFill>
                <a:latin typeface="Times New Roman"/>
              </a:rPr>
              <a:t>a  Nasal administration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5" name="Groupe 15"/>
          <p:cNvGrpSpPr/>
          <p:nvPr/>
        </p:nvGrpSpPr>
        <p:grpSpPr>
          <a:xfrm>
            <a:off x="5165640" y="4287960"/>
            <a:ext cx="2976480" cy="1727280"/>
            <a:chOff x="5165640" y="4287960"/>
            <a:chExt cx="2976480" cy="1727280"/>
          </a:xfrm>
        </p:grpSpPr>
        <p:sp>
          <p:nvSpPr>
            <p:cNvPr id="76" name="ZoneTexte 30"/>
            <p:cNvSpPr/>
            <p:nvPr/>
          </p:nvSpPr>
          <p:spPr>
            <a:xfrm>
              <a:off x="6918840" y="5556240"/>
              <a:ext cx="12232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</a:rPr>
                <a:t>NPD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Connecteur droit 32"/>
            <p:cNvSpPr/>
            <p:nvPr/>
          </p:nvSpPr>
          <p:spPr>
            <a:xfrm>
              <a:off x="5165640" y="5186520"/>
              <a:ext cx="0" cy="191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Connecteur droit 33"/>
            <p:cNvSpPr/>
            <p:nvPr/>
          </p:nvSpPr>
          <p:spPr>
            <a:xfrm>
              <a:off x="7531200" y="5184720"/>
              <a:ext cx="0" cy="191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79" name="Connecteur droit avec flèche 39"/>
            <p:cNvCxnSpPr/>
            <p:nvPr/>
          </p:nvCxnSpPr>
          <p:spPr>
            <a:xfrm flipV="1">
              <a:off x="7522920" y="5375160"/>
              <a:ext cx="1080" cy="892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</p:cxnSp>
        <p:grpSp>
          <p:nvGrpSpPr>
            <p:cNvPr id="80" name="Groupe 40"/>
            <p:cNvGrpSpPr/>
            <p:nvPr/>
          </p:nvGrpSpPr>
          <p:grpSpPr>
            <a:xfrm>
              <a:off x="5192280" y="4656240"/>
              <a:ext cx="2295000" cy="165240"/>
              <a:chOff x="5192280" y="4656240"/>
              <a:chExt cx="2295000" cy="165240"/>
            </a:xfrm>
          </p:grpSpPr>
          <p:sp>
            <p:nvSpPr>
              <p:cNvPr id="81" name="Connecteur droit 42"/>
              <p:cNvSpPr/>
              <p:nvPr/>
            </p:nvSpPr>
            <p:spPr>
              <a:xfrm>
                <a:off x="5192640" y="4656240"/>
                <a:ext cx="2294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82" name="Connecteur droit avec flèche 43"/>
              <p:cNvCxnSpPr/>
              <p:nvPr/>
            </p:nvCxnSpPr>
            <p:spPr>
              <a:xfrm>
                <a:off x="5192280" y="4656240"/>
                <a:ext cx="1080" cy="16560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  <p:cxnSp>
          <p:nvCxnSpPr>
            <p:cNvPr id="83" name="Connecteur droit avec flèche 89"/>
            <p:cNvCxnSpPr/>
            <p:nvPr/>
          </p:nvCxnSpPr>
          <p:spPr>
            <a:xfrm>
              <a:off x="7488000" y="4656240"/>
              <a:ext cx="1080" cy="16560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84" name="ZoneTexte 55"/>
            <p:cNvSpPr/>
            <p:nvPr/>
          </p:nvSpPr>
          <p:spPr>
            <a:xfrm>
              <a:off x="5636880" y="4287960"/>
              <a:ext cx="12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</a:rPr>
                <a:t>28 days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Connecteur droit 13"/>
            <p:cNvSpPr/>
            <p:nvPr/>
          </p:nvSpPr>
          <p:spPr>
            <a:xfrm>
              <a:off x="5165640" y="5375520"/>
              <a:ext cx="23655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6" name="ZoneTexte 55"/>
          <p:cNvSpPr/>
          <p:nvPr/>
        </p:nvSpPr>
        <p:spPr>
          <a:xfrm>
            <a:off x="291960" y="4836960"/>
            <a:ext cx="3368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2000" spc="-1" strike="noStrike">
                <a:solidFill>
                  <a:srgbClr val="000000"/>
                </a:solidFill>
                <a:latin typeface="Times New Roman"/>
              </a:rPr>
              <a:t>c Subcutaneous administration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ZoneTexte 1"/>
          <p:cNvSpPr/>
          <p:nvPr/>
        </p:nvSpPr>
        <p:spPr>
          <a:xfrm flipH="1">
            <a:off x="-4292640" y="4546440"/>
            <a:ext cx="257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20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ZoneTexte 55"/>
          <p:cNvSpPr/>
          <p:nvPr/>
        </p:nvSpPr>
        <p:spPr>
          <a:xfrm>
            <a:off x="289080" y="2857680"/>
            <a:ext cx="34988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2000" spc="-1" strike="noStrike">
                <a:solidFill>
                  <a:srgbClr val="000000"/>
                </a:solidFill>
                <a:latin typeface="Times New Roman"/>
              </a:rPr>
              <a:t>b  Intraperitoneal administration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9" name="Groupe 12"/>
          <p:cNvGrpSpPr/>
          <p:nvPr/>
        </p:nvGrpSpPr>
        <p:grpSpPr>
          <a:xfrm>
            <a:off x="3684600" y="2419200"/>
            <a:ext cx="2909880" cy="1567080"/>
            <a:chOff x="3684600" y="2419200"/>
            <a:chExt cx="2909880" cy="1567080"/>
          </a:xfrm>
        </p:grpSpPr>
        <p:grpSp>
          <p:nvGrpSpPr>
            <p:cNvPr id="90" name="Groupe 2"/>
            <p:cNvGrpSpPr/>
            <p:nvPr/>
          </p:nvGrpSpPr>
          <p:grpSpPr>
            <a:xfrm>
              <a:off x="3684600" y="2761560"/>
              <a:ext cx="2909880" cy="1224720"/>
              <a:chOff x="3684600" y="2761560"/>
              <a:chExt cx="2909880" cy="1224720"/>
            </a:xfrm>
          </p:grpSpPr>
          <p:sp>
            <p:nvSpPr>
              <p:cNvPr id="91" name="ZoneTexte 45"/>
              <p:cNvSpPr/>
              <p:nvPr/>
            </p:nvSpPr>
            <p:spPr>
              <a:xfrm>
                <a:off x="5594400" y="3527280"/>
                <a:ext cx="100008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</a:rPr>
                  <a:t>NPD 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Connecteur droit 90"/>
              <p:cNvSpPr/>
              <p:nvPr/>
            </p:nvSpPr>
            <p:spPr>
              <a:xfrm>
                <a:off x="4184640" y="3398760"/>
                <a:ext cx="1889280" cy="4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Connecteur droit 91"/>
              <p:cNvSpPr/>
              <p:nvPr/>
            </p:nvSpPr>
            <p:spPr>
              <a:xfrm>
                <a:off x="4184640" y="3220560"/>
                <a:ext cx="0" cy="177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Connecteur droit 92"/>
              <p:cNvSpPr/>
              <p:nvPr/>
            </p:nvSpPr>
            <p:spPr>
              <a:xfrm>
                <a:off x="5270400" y="3219120"/>
                <a:ext cx="0" cy="177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Connecteur droit 93"/>
              <p:cNvSpPr/>
              <p:nvPr/>
            </p:nvSpPr>
            <p:spPr>
              <a:xfrm>
                <a:off x="5527800" y="3219120"/>
                <a:ext cx="0" cy="177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" name="Connecteur droit 94"/>
              <p:cNvSpPr/>
              <p:nvPr/>
            </p:nvSpPr>
            <p:spPr>
              <a:xfrm>
                <a:off x="5784840" y="3219120"/>
                <a:ext cx="0" cy="177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" name="ZoneTexte 51"/>
              <p:cNvSpPr/>
              <p:nvPr/>
            </p:nvSpPr>
            <p:spPr>
              <a:xfrm>
                <a:off x="3684600" y="3520800"/>
                <a:ext cx="1000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</a:rPr>
                  <a:t>NPD 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" name="ZoneTexte 96"/>
              <p:cNvSpPr/>
              <p:nvPr/>
            </p:nvSpPr>
            <p:spPr>
              <a:xfrm>
                <a:off x="4157640" y="3214440"/>
                <a:ext cx="1150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 week (recovery)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" name="ZoneTexte 53"/>
              <p:cNvSpPr/>
              <p:nvPr/>
            </p:nvSpPr>
            <p:spPr>
              <a:xfrm>
                <a:off x="5256360" y="3220560"/>
                <a:ext cx="366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</a:rPr>
                  <a:t>D1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" name="ZoneTexte 54"/>
              <p:cNvSpPr/>
              <p:nvPr/>
            </p:nvSpPr>
            <p:spPr>
              <a:xfrm>
                <a:off x="5504040" y="3220560"/>
                <a:ext cx="368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</a:rPr>
                  <a:t>D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" name="Connecteur droit 99"/>
              <p:cNvSpPr/>
              <p:nvPr/>
            </p:nvSpPr>
            <p:spPr>
              <a:xfrm>
                <a:off x="6073920" y="3222360"/>
                <a:ext cx="0" cy="177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ZoneTexte 57"/>
              <p:cNvSpPr/>
              <p:nvPr/>
            </p:nvSpPr>
            <p:spPr>
              <a:xfrm>
                <a:off x="5775480" y="3214440"/>
                <a:ext cx="368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</a:rPr>
                  <a:t>D3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103" name="Connecteur droit avec flèche 102"/>
              <p:cNvCxnSpPr/>
              <p:nvPr/>
            </p:nvCxnSpPr>
            <p:spPr>
              <a:xfrm flipV="1">
                <a:off x="4184280" y="3417120"/>
                <a:ext cx="1080" cy="8316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  <p:grpSp>
            <p:nvGrpSpPr>
              <p:cNvPr id="104" name="Groupe 61"/>
              <p:cNvGrpSpPr/>
              <p:nvPr/>
            </p:nvGrpSpPr>
            <p:grpSpPr>
              <a:xfrm>
                <a:off x="5256000" y="2761560"/>
                <a:ext cx="817920" cy="292320"/>
                <a:chOff x="5256000" y="2761560"/>
                <a:chExt cx="817920" cy="292320"/>
              </a:xfrm>
            </p:grpSpPr>
            <p:sp>
              <p:nvSpPr>
                <p:cNvPr id="105" name="Connecteur droit 105"/>
                <p:cNvSpPr/>
                <p:nvPr/>
              </p:nvSpPr>
              <p:spPr>
                <a:xfrm>
                  <a:off x="5256360" y="2761920"/>
                  <a:ext cx="81756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cxnSp>
              <p:nvCxnSpPr>
                <p:cNvPr id="106" name="Connecteur droit avec flèche 106"/>
                <p:cNvCxnSpPr/>
                <p:nvPr/>
              </p:nvCxnSpPr>
              <p:spPr>
                <a:xfrm>
                  <a:off x="5256000" y="2761560"/>
                  <a:ext cx="1080" cy="283320"/>
                </a:xfrm>
                <a:prstGeom prst="straightConnector1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triangle" w="med"/>
                </a:ln>
              </p:spPr>
            </p:cxnSp>
            <p:cxnSp>
              <p:nvCxnSpPr>
                <p:cNvPr id="107" name="Connecteur droit avec flèche 107"/>
                <p:cNvCxnSpPr/>
                <p:nvPr/>
              </p:nvCxnSpPr>
              <p:spPr>
                <a:xfrm>
                  <a:off x="6072120" y="2770920"/>
                  <a:ext cx="1080" cy="283320"/>
                </a:xfrm>
                <a:prstGeom prst="straightConnector1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triangle" w="med"/>
                </a:ln>
              </p:spPr>
            </p:cxnSp>
          </p:grpSp>
          <p:cxnSp>
            <p:nvCxnSpPr>
              <p:cNvPr id="108" name="Connecteur droit avec flèche 108"/>
              <p:cNvCxnSpPr/>
              <p:nvPr/>
            </p:nvCxnSpPr>
            <p:spPr>
              <a:xfrm flipV="1">
                <a:off x="6078240" y="3439080"/>
                <a:ext cx="1080" cy="8316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  <p:sp>
          <p:nvSpPr>
            <p:cNvPr id="109" name="ZoneTexte 55"/>
            <p:cNvSpPr/>
            <p:nvPr/>
          </p:nvSpPr>
          <p:spPr>
            <a:xfrm>
              <a:off x="5079960" y="2419200"/>
              <a:ext cx="1084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</a:rPr>
                <a:t>Thrice a day 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0" name="Groupe 76"/>
          <p:cNvGrpSpPr/>
          <p:nvPr/>
        </p:nvGrpSpPr>
        <p:grpSpPr>
          <a:xfrm>
            <a:off x="6510240" y="2405160"/>
            <a:ext cx="2436840" cy="1567080"/>
            <a:chOff x="6510240" y="2405160"/>
            <a:chExt cx="2436840" cy="1567080"/>
          </a:xfrm>
        </p:grpSpPr>
        <p:grpSp>
          <p:nvGrpSpPr>
            <p:cNvPr id="111" name="Groupe 79"/>
            <p:cNvGrpSpPr/>
            <p:nvPr/>
          </p:nvGrpSpPr>
          <p:grpSpPr>
            <a:xfrm>
              <a:off x="6510240" y="2747520"/>
              <a:ext cx="2436840" cy="1224720"/>
              <a:chOff x="6510240" y="2747520"/>
              <a:chExt cx="2436840" cy="1224720"/>
            </a:xfrm>
          </p:grpSpPr>
          <p:sp>
            <p:nvSpPr>
              <p:cNvPr id="112" name="ZoneTexte 45"/>
              <p:cNvSpPr/>
              <p:nvPr/>
            </p:nvSpPr>
            <p:spPr>
              <a:xfrm>
                <a:off x="7947000" y="3513240"/>
                <a:ext cx="100008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</a:rPr>
                  <a:t>ICM 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" name="Connecteur droit 86"/>
              <p:cNvSpPr/>
              <p:nvPr/>
            </p:nvSpPr>
            <p:spPr>
              <a:xfrm>
                <a:off x="6536880" y="3384720"/>
                <a:ext cx="1889280" cy="4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" name="Connecteur droit 87"/>
              <p:cNvSpPr/>
              <p:nvPr/>
            </p:nvSpPr>
            <p:spPr>
              <a:xfrm>
                <a:off x="6536880" y="3206520"/>
                <a:ext cx="0" cy="177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" name="Connecteur droit 88"/>
              <p:cNvSpPr/>
              <p:nvPr/>
            </p:nvSpPr>
            <p:spPr>
              <a:xfrm>
                <a:off x="7623000" y="3205080"/>
                <a:ext cx="0" cy="177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" name="Connecteur droit 95"/>
              <p:cNvSpPr/>
              <p:nvPr/>
            </p:nvSpPr>
            <p:spPr>
              <a:xfrm>
                <a:off x="7880400" y="3205080"/>
                <a:ext cx="0" cy="177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" name="Connecteur droit 97"/>
              <p:cNvSpPr/>
              <p:nvPr/>
            </p:nvSpPr>
            <p:spPr>
              <a:xfrm>
                <a:off x="8137440" y="3205080"/>
                <a:ext cx="0" cy="177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" name="ZoneTexte 100"/>
              <p:cNvSpPr/>
              <p:nvPr/>
            </p:nvSpPr>
            <p:spPr>
              <a:xfrm>
                <a:off x="6510240" y="3200400"/>
                <a:ext cx="1150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 week (recovery)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" name="ZoneTexte 53"/>
              <p:cNvSpPr/>
              <p:nvPr/>
            </p:nvSpPr>
            <p:spPr>
              <a:xfrm>
                <a:off x="7608960" y="3206520"/>
                <a:ext cx="366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</a:rPr>
                  <a:t>D1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" name="ZoneTexte 54"/>
              <p:cNvSpPr/>
              <p:nvPr/>
            </p:nvSpPr>
            <p:spPr>
              <a:xfrm>
                <a:off x="7856640" y="3206520"/>
                <a:ext cx="368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</a:rPr>
                  <a:t>D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" name="Connecteur droit 104"/>
              <p:cNvSpPr/>
              <p:nvPr/>
            </p:nvSpPr>
            <p:spPr>
              <a:xfrm>
                <a:off x="8426520" y="3208320"/>
                <a:ext cx="0" cy="177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2" name="ZoneTexte 57"/>
              <p:cNvSpPr/>
              <p:nvPr/>
            </p:nvSpPr>
            <p:spPr>
              <a:xfrm>
                <a:off x="8128080" y="3200400"/>
                <a:ext cx="368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</a:rPr>
                  <a:t>D3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123" name="Connecteur droit avec flèche 110"/>
              <p:cNvCxnSpPr/>
              <p:nvPr/>
            </p:nvCxnSpPr>
            <p:spPr>
              <a:xfrm flipV="1">
                <a:off x="6536520" y="3403080"/>
                <a:ext cx="1080" cy="8316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  <p:grpSp>
            <p:nvGrpSpPr>
              <p:cNvPr id="124" name="Groupe 61"/>
              <p:cNvGrpSpPr/>
              <p:nvPr/>
            </p:nvGrpSpPr>
            <p:grpSpPr>
              <a:xfrm>
                <a:off x="7608600" y="2747520"/>
                <a:ext cx="817920" cy="292320"/>
                <a:chOff x="7608600" y="2747520"/>
                <a:chExt cx="817920" cy="292320"/>
              </a:xfrm>
            </p:grpSpPr>
            <p:sp>
              <p:nvSpPr>
                <p:cNvPr id="125" name="Connecteur droit 113"/>
                <p:cNvSpPr/>
                <p:nvPr/>
              </p:nvSpPr>
              <p:spPr>
                <a:xfrm>
                  <a:off x="7608960" y="2747880"/>
                  <a:ext cx="81756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cxnSp>
              <p:nvCxnSpPr>
                <p:cNvPr id="126" name="Connecteur droit avec flèche 114"/>
                <p:cNvCxnSpPr/>
                <p:nvPr/>
              </p:nvCxnSpPr>
              <p:spPr>
                <a:xfrm>
                  <a:off x="7608600" y="2747520"/>
                  <a:ext cx="1080" cy="283320"/>
                </a:xfrm>
                <a:prstGeom prst="straightConnector1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triangle" w="med"/>
                </a:ln>
              </p:spPr>
            </p:cxnSp>
            <p:cxnSp>
              <p:nvCxnSpPr>
                <p:cNvPr id="127" name="Connecteur droit avec flèche 115"/>
                <p:cNvCxnSpPr/>
                <p:nvPr/>
              </p:nvCxnSpPr>
              <p:spPr>
                <a:xfrm>
                  <a:off x="8424720" y="2756880"/>
                  <a:ext cx="1080" cy="283320"/>
                </a:xfrm>
                <a:prstGeom prst="straightConnector1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triangle" w="med"/>
                </a:ln>
              </p:spPr>
            </p:cxnSp>
          </p:grpSp>
          <p:cxnSp>
            <p:nvCxnSpPr>
              <p:cNvPr id="128" name="Connecteur droit avec flèche 112"/>
              <p:cNvCxnSpPr/>
              <p:nvPr/>
            </p:nvCxnSpPr>
            <p:spPr>
              <a:xfrm flipV="1">
                <a:off x="8430840" y="3425040"/>
                <a:ext cx="1080" cy="8316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  <p:sp>
          <p:nvSpPr>
            <p:cNvPr id="129" name="ZoneTexte 55"/>
            <p:cNvSpPr/>
            <p:nvPr/>
          </p:nvSpPr>
          <p:spPr>
            <a:xfrm>
              <a:off x="7432560" y="2405160"/>
              <a:ext cx="1084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</a:rPr>
                <a:t>Thrice a day 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65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8-10T06:45:07Z</dcterms:created>
  <dc:creator>EDELMAN</dc:creator>
  <dc:description/>
  <dc:language>en-US</dc:language>
  <cp:lastModifiedBy>SERMET-GAUDELUS Isabelle</cp:lastModifiedBy>
  <cp:lastPrinted>2017-06-13T14:05:16Z</cp:lastPrinted>
  <dcterms:modified xsi:type="dcterms:W3CDTF">2021-11-30T17:33:15Z</dcterms:modified>
  <cp:revision>606</cp:revision>
  <dc:subject/>
  <dc:title>Présentation PowerPoint</dc:title>
</cp:coreProperties>
</file>